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53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17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524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521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60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758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535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115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846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855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356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561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984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D274F2D-35A2-AC21-720C-FF7381BD59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7905" y="1222774"/>
            <a:ext cx="6872517" cy="422683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BED07CF-E6A9-52FE-838E-A6960A0AE698}"/>
              </a:ext>
            </a:extLst>
          </p:cNvPr>
          <p:cNvSpPr txBox="1"/>
          <p:nvPr/>
        </p:nvSpPr>
        <p:spPr>
          <a:xfrm>
            <a:off x="914400" y="597877"/>
            <a:ext cx="3603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B BNPage proband 6 (L109S)</a:t>
            </a:r>
          </a:p>
        </p:txBody>
      </p:sp>
    </p:spTree>
    <p:extLst>
      <p:ext uri="{BB962C8B-B14F-4D97-AF65-F5344CB8AC3E}">
        <p14:creationId xmlns:p14="http://schemas.microsoft.com/office/powerpoint/2010/main" val="3560374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98939" y="208861"/>
            <a:ext cx="1243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mplex 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592181" y="1765256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139632" y="1765256"/>
            <a:ext cx="1171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band 6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5072A77-031E-3BF3-7225-7B444CF402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5969" y="2134588"/>
            <a:ext cx="8120062" cy="2980933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7753E8E0-72AB-21BE-72E9-E41060E5C9A7}"/>
              </a:ext>
            </a:extLst>
          </p:cNvPr>
          <p:cNvSpPr/>
          <p:nvPr/>
        </p:nvSpPr>
        <p:spPr>
          <a:xfrm>
            <a:off x="2592182" y="2329962"/>
            <a:ext cx="1243913" cy="139706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68FAB9D-E6FA-9A2F-A21F-40B9DF421A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49344" y="2329962"/>
            <a:ext cx="1261981" cy="14143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47276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155145"/>
            <a:ext cx="166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mplex 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037026" y="1744109"/>
            <a:ext cx="1243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band 6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703833" y="1744109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pic>
        <p:nvPicPr>
          <p:cNvPr id="7" name="Picture 6" descr="A blue and white image&#10;&#10;AI-generated content may be incorrect.">
            <a:extLst>
              <a:ext uri="{FF2B5EF4-FFF2-40B4-BE49-F238E27FC236}">
                <a16:creationId xmlns:a16="http://schemas.microsoft.com/office/drawing/2014/main" id="{532F04C6-F275-F8DA-8D8B-2F07B043DB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0808" y="2113442"/>
            <a:ext cx="7988879" cy="355877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A4EA20EE-5DBA-A9D9-FF0A-B6E579F358AF}"/>
              </a:ext>
            </a:extLst>
          </p:cNvPr>
          <p:cNvSpPr/>
          <p:nvPr/>
        </p:nvSpPr>
        <p:spPr>
          <a:xfrm>
            <a:off x="2708031" y="3708913"/>
            <a:ext cx="1239715" cy="74734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D5C6FBA-D0C2-6372-3F98-96780E4169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37026" y="3708913"/>
            <a:ext cx="1255885" cy="7681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57142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71899" y="1092755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909012" y="1092755"/>
            <a:ext cx="1243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band 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ED27516-D05C-7968-B0D9-CC9D4E7CBE34}"/>
              </a:ext>
            </a:extLst>
          </p:cNvPr>
          <p:cNvSpPr txBox="1"/>
          <p:nvPr/>
        </p:nvSpPr>
        <p:spPr>
          <a:xfrm>
            <a:off x="96715" y="111211"/>
            <a:ext cx="16815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mplex 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9217C8F-09BA-4A70-6BE4-9F63FEAD2F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5602" y="1462087"/>
            <a:ext cx="6229350" cy="3933825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5D415739-2CFD-355C-6FBF-77BDCF920EC4}"/>
              </a:ext>
            </a:extLst>
          </p:cNvPr>
          <p:cNvSpPr/>
          <p:nvPr/>
        </p:nvSpPr>
        <p:spPr>
          <a:xfrm>
            <a:off x="2901462" y="2479431"/>
            <a:ext cx="1011115" cy="23739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5B787BF-FB7C-76E1-9D8D-96B83CE238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15812" y="2479431"/>
            <a:ext cx="1030313" cy="2391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51423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175846" y="68091"/>
            <a:ext cx="1774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mplex 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956901" y="862989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058171" y="862989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band 6</a:t>
            </a:r>
          </a:p>
        </p:txBody>
      </p:sp>
      <p:pic>
        <p:nvPicPr>
          <p:cNvPr id="6" name="Picture 5" descr="A close-up of a plastic bag&#10;&#10;AI-generated content may be incorrect.">
            <a:extLst>
              <a:ext uri="{FF2B5EF4-FFF2-40B4-BE49-F238E27FC236}">
                <a16:creationId xmlns:a16="http://schemas.microsoft.com/office/drawing/2014/main" id="{7A06C5A3-A498-6497-4B8A-B5CD85EF61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8854" y="1232322"/>
            <a:ext cx="7611800" cy="390766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07180F4-3494-0CED-F93C-DA59EBEC30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25222" y="1939631"/>
            <a:ext cx="958629" cy="251807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000439A-A243-47CB-A29D-E87813993A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00814" y="1927117"/>
            <a:ext cx="958629" cy="25180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2346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28</Words>
  <Application>Microsoft Office PowerPoint</Application>
  <PresentationFormat>Widescreen</PresentationFormat>
  <Paragraphs>1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hildren's Hospital Colorad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se, Tonia</dc:creator>
  <cp:lastModifiedBy>Friederich, Marisa</cp:lastModifiedBy>
  <cp:revision>17</cp:revision>
  <dcterms:created xsi:type="dcterms:W3CDTF">2024-09-05T16:18:17Z</dcterms:created>
  <dcterms:modified xsi:type="dcterms:W3CDTF">2025-05-05T23:14:12Z</dcterms:modified>
</cp:coreProperties>
</file>